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7315200" cy="96012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38" autoAdjust="0"/>
    <p:restoredTop sz="94660"/>
  </p:normalViewPr>
  <p:slideViewPr>
    <p:cSldViewPr>
      <p:cViewPr>
        <p:scale>
          <a:sx n="61" d="100"/>
          <a:sy n="61" d="100"/>
        </p:scale>
        <p:origin x="-3198" y="-6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AA0EC2-0D9D-4E53-A689-6CDF1D0FC2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945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C5B7683-DB98-4859-AF1D-F30CE4F39F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097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A3B5F3-22BB-403C-B76A-91E12427949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44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996947-481D-47DA-A7C0-5CF125831A3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060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D684EF-2477-4A46-B79A-EB89594950C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093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29C4D5A-E574-4CAD-A241-5EF99ADD24E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722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B00447-74FB-4F43-8986-DC854A34EF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823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B4705DD-7092-43E6-9132-ED98203F94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075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90E916-7D67-4592-BF7F-313C1A80484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446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0C1B3D-2A76-429F-ACE1-62E1D74008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165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927399-5974-43A3-B1A8-F7DB0BDDCB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856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79641D16-FBB2-4F98-A21A-7F2E23182D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hyperlink" Target="http://aramemnon.botanik.uni-koeln.de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16632" y="323528"/>
            <a:ext cx="5897383" cy="5436696"/>
            <a:chOff x="1043608" y="88057"/>
            <a:chExt cx="7369366" cy="6696744"/>
          </a:xfrm>
        </p:grpSpPr>
        <p:grpSp>
          <p:nvGrpSpPr>
            <p:cNvPr id="9" name="Group 8"/>
            <p:cNvGrpSpPr/>
            <p:nvPr/>
          </p:nvGrpSpPr>
          <p:grpSpPr>
            <a:xfrm>
              <a:off x="5004048" y="88057"/>
              <a:ext cx="3408926" cy="6696744"/>
              <a:chOff x="3835666" y="-29917"/>
              <a:chExt cx="3408926" cy="6696744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3835666" y="-29917"/>
                <a:ext cx="2926466" cy="6696744"/>
                <a:chOff x="3835666" y="-29917"/>
                <a:chExt cx="2926466" cy="6696744"/>
              </a:xfrm>
            </p:grpSpPr>
            <p:grpSp>
              <p:nvGrpSpPr>
                <p:cNvPr id="41" name="Group 40"/>
                <p:cNvGrpSpPr/>
                <p:nvPr/>
              </p:nvGrpSpPr>
              <p:grpSpPr>
                <a:xfrm>
                  <a:off x="3835666" y="-29917"/>
                  <a:ext cx="2926466" cy="6696744"/>
                  <a:chOff x="3835666" y="-27384"/>
                  <a:chExt cx="2926466" cy="6696744"/>
                </a:xfrm>
              </p:grpSpPr>
              <p:pic>
                <p:nvPicPr>
                  <p:cNvPr id="44" name="Picture 43"/>
                  <p:cNvPicPr>
                    <a:picLocks noChangeAspect="1"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835666" y="-27384"/>
                    <a:ext cx="1440193" cy="6696744"/>
                  </a:xfrm>
                  <a:prstGeom prst="rect">
                    <a:avLst/>
                  </a:prstGeom>
                </p:spPr>
              </p:pic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5058294" y="4128352"/>
                    <a:ext cx="1703838" cy="4170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600" b="1" i="1" dirty="0" smtClean="0">
                        <a:solidFill>
                          <a:srgbClr val="0070C0"/>
                        </a:solidFill>
                      </a:rPr>
                      <a:t>At</a:t>
                    </a:r>
                    <a:r>
                      <a:rPr lang="en-GB" sz="600" b="1" dirty="0" smtClean="0">
                        <a:solidFill>
                          <a:srgbClr val="0070C0"/>
                        </a:solidFill>
                      </a:rPr>
                      <a:t>CAT9</a:t>
                    </a:r>
                  </a:p>
                  <a:p>
                    <a:endParaRPr lang="en-GB" sz="400" dirty="0"/>
                  </a:p>
                  <a:p>
                    <a:r>
                      <a:rPr lang="en-GB" sz="600" b="1" i="1" dirty="0" smtClean="0">
                        <a:solidFill>
                          <a:srgbClr val="0070C0"/>
                        </a:solidFill>
                      </a:rPr>
                      <a:t>Sl</a:t>
                    </a:r>
                    <a:r>
                      <a:rPr lang="en-GB" sz="600" b="1" dirty="0" smtClean="0">
                        <a:solidFill>
                          <a:srgbClr val="0070C0"/>
                        </a:solidFill>
                      </a:rPr>
                      <a:t>CAT9</a:t>
                    </a:r>
                    <a:endParaRPr lang="en-GB" sz="600" b="1" dirty="0">
                      <a:solidFill>
                        <a:srgbClr val="0070C0"/>
                      </a:solidFill>
                    </a:endParaRPr>
                  </a:p>
                </p:txBody>
              </p:sp>
              <p:cxnSp>
                <p:nvCxnSpPr>
                  <p:cNvPr id="46" name="Straight Arrow Connector 45"/>
                  <p:cNvCxnSpPr/>
                  <p:nvPr/>
                </p:nvCxnSpPr>
                <p:spPr>
                  <a:xfrm flipH="1">
                    <a:off x="4941453" y="4267766"/>
                    <a:ext cx="216024" cy="0"/>
                  </a:xfrm>
                  <a:prstGeom prst="straightConnector1">
                    <a:avLst/>
                  </a:prstGeom>
                  <a:ln w="9525">
                    <a:tailEnd type="triangle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7" name="Straight Arrow Connector 46"/>
                  <p:cNvCxnSpPr/>
                  <p:nvPr/>
                </p:nvCxnSpPr>
                <p:spPr>
                  <a:xfrm flipH="1">
                    <a:off x="4937106" y="4416848"/>
                    <a:ext cx="216024" cy="0"/>
                  </a:xfrm>
                  <a:prstGeom prst="straightConnector1">
                    <a:avLst/>
                  </a:prstGeom>
                  <a:ln w="9525">
                    <a:tailEnd type="triangle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2" name="Right Brace 41"/>
                <p:cNvSpPr/>
                <p:nvPr/>
              </p:nvSpPr>
              <p:spPr>
                <a:xfrm>
                  <a:off x="5534393" y="3722098"/>
                  <a:ext cx="45719" cy="720080"/>
                </a:xfrm>
                <a:prstGeom prst="righ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5580111" y="3831431"/>
                  <a:ext cx="801534" cy="5686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dirty="0" smtClean="0"/>
                    <a:t>CAT9 clade</a:t>
                  </a:r>
                  <a:endParaRPr lang="en-GB" sz="1200" dirty="0"/>
                </a:p>
              </p:txBody>
            </p:sp>
          </p:grpSp>
          <p:grpSp>
            <p:nvGrpSpPr>
              <p:cNvPr id="17" name="Group 16"/>
              <p:cNvGrpSpPr/>
              <p:nvPr/>
            </p:nvGrpSpPr>
            <p:grpSpPr>
              <a:xfrm>
                <a:off x="4932040" y="5044534"/>
                <a:ext cx="1961716" cy="227466"/>
                <a:chOff x="5093853" y="3212976"/>
                <a:chExt cx="1961716" cy="227466"/>
              </a:xfrm>
            </p:grpSpPr>
            <p:sp>
              <p:nvSpPr>
                <p:cNvPr id="39" name="TextBox 38"/>
                <p:cNvSpPr txBox="1"/>
                <p:nvPr/>
              </p:nvSpPr>
              <p:spPr>
                <a:xfrm>
                  <a:off x="5252337" y="3212976"/>
                  <a:ext cx="1803232" cy="2274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i="1" dirty="0" smtClean="0">
                      <a:solidFill>
                        <a:srgbClr val="0070C0"/>
                      </a:solidFill>
                    </a:rPr>
                    <a:t>At</a:t>
                  </a:r>
                  <a:r>
                    <a:rPr lang="en-GB" sz="600" b="1" dirty="0" smtClean="0">
                      <a:solidFill>
                        <a:srgbClr val="0070C0"/>
                      </a:solidFill>
                    </a:rPr>
                    <a:t>CAT4</a:t>
                  </a:r>
                </a:p>
              </p:txBody>
            </p:sp>
            <p:cxnSp>
              <p:nvCxnSpPr>
                <p:cNvPr id="40" name="Straight Arrow Connector 39"/>
                <p:cNvCxnSpPr/>
                <p:nvPr/>
              </p:nvCxnSpPr>
              <p:spPr>
                <a:xfrm flipH="1">
                  <a:off x="5093853" y="3307195"/>
                  <a:ext cx="216024" cy="0"/>
                </a:xfrm>
                <a:prstGeom prst="straightConnector1">
                  <a:avLst/>
                </a:prstGeom>
                <a:ln w="9525"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" name="Group 17"/>
              <p:cNvGrpSpPr/>
              <p:nvPr/>
            </p:nvGrpSpPr>
            <p:grpSpPr>
              <a:xfrm>
                <a:off x="4932040" y="5515771"/>
                <a:ext cx="864407" cy="227465"/>
                <a:chOff x="5093853" y="3189361"/>
                <a:chExt cx="864407" cy="227465"/>
              </a:xfrm>
            </p:grpSpPr>
            <p:sp>
              <p:nvSpPr>
                <p:cNvPr id="37" name="TextBox 36"/>
                <p:cNvSpPr txBox="1"/>
                <p:nvPr/>
              </p:nvSpPr>
              <p:spPr>
                <a:xfrm>
                  <a:off x="5234802" y="3189361"/>
                  <a:ext cx="723458" cy="2274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i="1" dirty="0" smtClean="0">
                      <a:solidFill>
                        <a:srgbClr val="0070C0"/>
                      </a:solidFill>
                    </a:rPr>
                    <a:t>At</a:t>
                  </a:r>
                  <a:r>
                    <a:rPr lang="en-GB" sz="600" b="1" dirty="0" smtClean="0">
                      <a:solidFill>
                        <a:srgbClr val="0070C0"/>
                      </a:solidFill>
                    </a:rPr>
                    <a:t>CAT3</a:t>
                  </a:r>
                </a:p>
              </p:txBody>
            </p:sp>
            <p:cxnSp>
              <p:nvCxnSpPr>
                <p:cNvPr id="38" name="Straight Arrow Connector 37"/>
                <p:cNvCxnSpPr/>
                <p:nvPr/>
              </p:nvCxnSpPr>
              <p:spPr>
                <a:xfrm flipH="1">
                  <a:off x="5093853" y="3307195"/>
                  <a:ext cx="216024" cy="0"/>
                </a:xfrm>
                <a:prstGeom prst="straightConnector1">
                  <a:avLst/>
                </a:prstGeom>
                <a:ln w="9525"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" name="Group 18"/>
              <p:cNvGrpSpPr/>
              <p:nvPr/>
            </p:nvGrpSpPr>
            <p:grpSpPr>
              <a:xfrm>
                <a:off x="4932040" y="5606802"/>
                <a:ext cx="1479780" cy="227466"/>
                <a:chOff x="5093853" y="3211452"/>
                <a:chExt cx="1479780" cy="227466"/>
              </a:xfrm>
            </p:grpSpPr>
            <p:sp>
              <p:nvSpPr>
                <p:cNvPr id="35" name="TextBox 34"/>
                <p:cNvSpPr txBox="1"/>
                <p:nvPr/>
              </p:nvSpPr>
              <p:spPr>
                <a:xfrm>
                  <a:off x="5234802" y="3211452"/>
                  <a:ext cx="1338831" cy="2274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i="1" dirty="0" smtClean="0">
                      <a:solidFill>
                        <a:srgbClr val="0070C0"/>
                      </a:solidFill>
                    </a:rPr>
                    <a:t>At</a:t>
                  </a:r>
                  <a:r>
                    <a:rPr lang="en-GB" sz="600" b="1" dirty="0" smtClean="0">
                      <a:solidFill>
                        <a:srgbClr val="0070C0"/>
                      </a:solidFill>
                    </a:rPr>
                    <a:t>CAT2</a:t>
                  </a:r>
                </a:p>
              </p:txBody>
            </p:sp>
            <p:cxnSp>
              <p:nvCxnSpPr>
                <p:cNvPr id="36" name="Straight Arrow Connector 35"/>
                <p:cNvCxnSpPr/>
                <p:nvPr/>
              </p:nvCxnSpPr>
              <p:spPr>
                <a:xfrm flipH="1">
                  <a:off x="5093853" y="3307195"/>
                  <a:ext cx="216024" cy="0"/>
                </a:xfrm>
                <a:prstGeom prst="straightConnector1">
                  <a:avLst/>
                </a:prstGeom>
                <a:ln w="9525"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" name="Group 19"/>
              <p:cNvGrpSpPr/>
              <p:nvPr/>
            </p:nvGrpSpPr>
            <p:grpSpPr>
              <a:xfrm>
                <a:off x="4941244" y="2959268"/>
                <a:ext cx="2303348" cy="227466"/>
                <a:chOff x="5093853" y="3184496"/>
                <a:chExt cx="2303348" cy="227466"/>
              </a:xfrm>
            </p:grpSpPr>
            <p:sp>
              <p:nvSpPr>
                <p:cNvPr id="33" name="TextBox 32"/>
                <p:cNvSpPr txBox="1"/>
                <p:nvPr/>
              </p:nvSpPr>
              <p:spPr>
                <a:xfrm>
                  <a:off x="5243249" y="3184496"/>
                  <a:ext cx="2153952" cy="2274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i="1" dirty="0" smtClean="0">
                      <a:solidFill>
                        <a:srgbClr val="0070C0"/>
                      </a:solidFill>
                    </a:rPr>
                    <a:t>At</a:t>
                  </a:r>
                  <a:r>
                    <a:rPr lang="en-GB" sz="600" b="1" dirty="0" smtClean="0">
                      <a:solidFill>
                        <a:srgbClr val="0070C0"/>
                      </a:solidFill>
                    </a:rPr>
                    <a:t>CAT6</a:t>
                  </a:r>
                </a:p>
              </p:txBody>
            </p:sp>
            <p:cxnSp>
              <p:nvCxnSpPr>
                <p:cNvPr id="34" name="Straight Arrow Connector 33"/>
                <p:cNvCxnSpPr/>
                <p:nvPr/>
              </p:nvCxnSpPr>
              <p:spPr>
                <a:xfrm flipH="1">
                  <a:off x="5093853" y="3307195"/>
                  <a:ext cx="216024" cy="0"/>
                </a:xfrm>
                <a:prstGeom prst="straightConnector1">
                  <a:avLst/>
                </a:prstGeom>
                <a:ln w="9525"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" name="Group 20"/>
              <p:cNvGrpSpPr/>
              <p:nvPr/>
            </p:nvGrpSpPr>
            <p:grpSpPr>
              <a:xfrm>
                <a:off x="4941244" y="3058551"/>
                <a:ext cx="1591726" cy="227466"/>
                <a:chOff x="5093853" y="3214161"/>
                <a:chExt cx="1591726" cy="227466"/>
              </a:xfrm>
            </p:grpSpPr>
            <p:sp>
              <p:nvSpPr>
                <p:cNvPr id="31" name="TextBox 30"/>
                <p:cNvSpPr txBox="1"/>
                <p:nvPr/>
              </p:nvSpPr>
              <p:spPr>
                <a:xfrm>
                  <a:off x="5245387" y="3214161"/>
                  <a:ext cx="1440192" cy="2274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i="1" dirty="0" smtClean="0">
                      <a:solidFill>
                        <a:srgbClr val="0070C0"/>
                      </a:solidFill>
                    </a:rPr>
                    <a:t>At</a:t>
                  </a:r>
                  <a:r>
                    <a:rPr lang="en-GB" sz="600" b="1" dirty="0" smtClean="0">
                      <a:solidFill>
                        <a:srgbClr val="0070C0"/>
                      </a:solidFill>
                    </a:rPr>
                    <a:t>CAT7</a:t>
                  </a:r>
                </a:p>
              </p:txBody>
            </p:sp>
            <p:cxnSp>
              <p:nvCxnSpPr>
                <p:cNvPr id="32" name="Straight Arrow Connector 31"/>
                <p:cNvCxnSpPr/>
                <p:nvPr/>
              </p:nvCxnSpPr>
              <p:spPr>
                <a:xfrm flipH="1">
                  <a:off x="5093853" y="3307195"/>
                  <a:ext cx="216024" cy="0"/>
                </a:xfrm>
                <a:prstGeom prst="straightConnector1">
                  <a:avLst/>
                </a:prstGeom>
                <a:ln w="9525"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" name="Group 21"/>
              <p:cNvGrpSpPr/>
              <p:nvPr/>
            </p:nvGrpSpPr>
            <p:grpSpPr>
              <a:xfrm>
                <a:off x="5180188" y="1753608"/>
                <a:ext cx="1370465" cy="227466"/>
                <a:chOff x="5093853" y="3190700"/>
                <a:chExt cx="1370465" cy="227466"/>
              </a:xfrm>
            </p:grpSpPr>
            <p:sp>
              <p:nvSpPr>
                <p:cNvPr id="29" name="TextBox 28"/>
                <p:cNvSpPr txBox="1"/>
                <p:nvPr/>
              </p:nvSpPr>
              <p:spPr>
                <a:xfrm>
                  <a:off x="5214036" y="3190700"/>
                  <a:ext cx="1250282" cy="2274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i="1" dirty="0" smtClean="0">
                      <a:solidFill>
                        <a:srgbClr val="0070C0"/>
                      </a:solidFill>
                    </a:rPr>
                    <a:t>At</a:t>
                  </a:r>
                  <a:r>
                    <a:rPr lang="en-GB" sz="600" b="1" dirty="0" smtClean="0">
                      <a:solidFill>
                        <a:srgbClr val="0070C0"/>
                      </a:solidFill>
                    </a:rPr>
                    <a:t>CAT8</a:t>
                  </a:r>
                </a:p>
              </p:txBody>
            </p:sp>
            <p:cxnSp>
              <p:nvCxnSpPr>
                <p:cNvPr id="30" name="Straight Arrow Connector 29"/>
                <p:cNvCxnSpPr/>
                <p:nvPr/>
              </p:nvCxnSpPr>
              <p:spPr>
                <a:xfrm flipH="1">
                  <a:off x="5093853" y="3307195"/>
                  <a:ext cx="216024" cy="0"/>
                </a:xfrm>
                <a:prstGeom prst="straightConnector1">
                  <a:avLst/>
                </a:prstGeom>
                <a:ln w="9525"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" name="Group 22"/>
              <p:cNvGrpSpPr/>
              <p:nvPr/>
            </p:nvGrpSpPr>
            <p:grpSpPr>
              <a:xfrm>
                <a:off x="5072988" y="1495443"/>
                <a:ext cx="1488450" cy="227466"/>
                <a:chOff x="5093853" y="3202159"/>
                <a:chExt cx="1488450" cy="227466"/>
              </a:xfrm>
            </p:grpSpPr>
            <p:sp>
              <p:nvSpPr>
                <p:cNvPr id="27" name="TextBox 26"/>
                <p:cNvSpPr txBox="1"/>
                <p:nvPr/>
              </p:nvSpPr>
              <p:spPr>
                <a:xfrm>
                  <a:off x="5224821" y="3202159"/>
                  <a:ext cx="1357482" cy="2274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i="1" dirty="0" smtClean="0">
                      <a:solidFill>
                        <a:srgbClr val="0070C0"/>
                      </a:solidFill>
                    </a:rPr>
                    <a:t>At</a:t>
                  </a:r>
                  <a:r>
                    <a:rPr lang="en-GB" sz="600" b="1" dirty="0" smtClean="0">
                      <a:solidFill>
                        <a:srgbClr val="0070C0"/>
                      </a:solidFill>
                    </a:rPr>
                    <a:t>CAT5</a:t>
                  </a:r>
                </a:p>
              </p:txBody>
            </p:sp>
            <p:cxnSp>
              <p:nvCxnSpPr>
                <p:cNvPr id="28" name="Straight Arrow Connector 27"/>
                <p:cNvCxnSpPr/>
                <p:nvPr/>
              </p:nvCxnSpPr>
              <p:spPr>
                <a:xfrm flipH="1">
                  <a:off x="5093853" y="3307195"/>
                  <a:ext cx="216024" cy="0"/>
                </a:xfrm>
                <a:prstGeom prst="straightConnector1">
                  <a:avLst/>
                </a:prstGeom>
                <a:ln w="9525"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" name="Group 23"/>
              <p:cNvGrpSpPr/>
              <p:nvPr/>
            </p:nvGrpSpPr>
            <p:grpSpPr>
              <a:xfrm>
                <a:off x="5084346" y="949427"/>
                <a:ext cx="1308428" cy="227466"/>
                <a:chOff x="5050739" y="3181675"/>
                <a:chExt cx="1308428" cy="227466"/>
              </a:xfrm>
            </p:grpSpPr>
            <p:sp>
              <p:nvSpPr>
                <p:cNvPr id="25" name="TextBox 24"/>
                <p:cNvSpPr txBox="1"/>
                <p:nvPr/>
              </p:nvSpPr>
              <p:spPr>
                <a:xfrm>
                  <a:off x="5172640" y="3181675"/>
                  <a:ext cx="1186527" cy="2274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600" b="1" i="1" dirty="0" smtClean="0">
                      <a:solidFill>
                        <a:srgbClr val="0070C0"/>
                      </a:solidFill>
                    </a:rPr>
                    <a:t>At</a:t>
                  </a:r>
                  <a:r>
                    <a:rPr lang="en-GB" sz="600" b="1" dirty="0" smtClean="0">
                      <a:solidFill>
                        <a:srgbClr val="0070C0"/>
                      </a:solidFill>
                    </a:rPr>
                    <a:t>CAT1/</a:t>
                  </a:r>
                  <a:r>
                    <a:rPr lang="en-GB" sz="600" b="1" i="1" dirty="0" smtClean="0">
                      <a:solidFill>
                        <a:srgbClr val="0070C0"/>
                      </a:solidFill>
                    </a:rPr>
                    <a:t>At</a:t>
                  </a:r>
                  <a:r>
                    <a:rPr lang="en-GB" sz="600" b="1" dirty="0" smtClean="0">
                      <a:solidFill>
                        <a:srgbClr val="0070C0"/>
                      </a:solidFill>
                    </a:rPr>
                    <a:t>AAT1</a:t>
                  </a:r>
                </a:p>
              </p:txBody>
            </p:sp>
            <p:cxnSp>
              <p:nvCxnSpPr>
                <p:cNvPr id="26" name="Straight Arrow Connector 25"/>
                <p:cNvCxnSpPr/>
                <p:nvPr/>
              </p:nvCxnSpPr>
              <p:spPr>
                <a:xfrm flipH="1">
                  <a:off x="5050739" y="3307195"/>
                  <a:ext cx="216024" cy="0"/>
                </a:xfrm>
                <a:prstGeom prst="straightConnector1">
                  <a:avLst/>
                </a:prstGeom>
                <a:ln w="9525"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0" name="Group 9"/>
            <p:cNvGrpSpPr/>
            <p:nvPr/>
          </p:nvGrpSpPr>
          <p:grpSpPr>
            <a:xfrm>
              <a:off x="1691680" y="254931"/>
              <a:ext cx="3096081" cy="2670013"/>
              <a:chOff x="2024424" y="332656"/>
              <a:chExt cx="7264389" cy="6264696"/>
            </a:xfrm>
          </p:grpSpPr>
          <p:sp>
            <p:nvSpPr>
              <p:cNvPr id="13" name="Arc 12"/>
              <p:cNvSpPr/>
              <p:nvPr/>
            </p:nvSpPr>
            <p:spPr>
              <a:xfrm rot="3317747">
                <a:off x="5500049" y="3860744"/>
                <a:ext cx="1662871" cy="1911189"/>
              </a:xfrm>
              <a:prstGeom prst="arc">
                <a:avLst>
                  <a:gd name="adj1" fmla="val 16005146"/>
                  <a:gd name="adj2" fmla="val 1759309"/>
                </a:avLst>
              </a:prstGeom>
              <a:ln w="1905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rgbClr val="002060"/>
                  </a:solidFill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7275122" y="4954815"/>
                <a:ext cx="2013691" cy="8895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700" dirty="0" smtClean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T9</a:t>
                </a:r>
              </a:p>
              <a:p>
                <a:pPr algn="ctr"/>
                <a:r>
                  <a:rPr lang="en-GB" sz="700" dirty="0" smtClean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lade</a:t>
                </a:r>
                <a:endParaRPr lang="en-GB" sz="7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24424" y="332656"/>
                <a:ext cx="5065400" cy="6264696"/>
              </a:xfrm>
              <a:prstGeom prst="rect">
                <a:avLst/>
              </a:prstGeom>
            </p:spPr>
          </p:pic>
        </p:grpSp>
        <p:sp>
          <p:nvSpPr>
            <p:cNvPr id="11" name="TextBox 10"/>
            <p:cNvSpPr txBox="1"/>
            <p:nvPr/>
          </p:nvSpPr>
          <p:spPr>
            <a:xfrm>
              <a:off x="1043608" y="188640"/>
              <a:ext cx="43204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b="1" dirty="0" smtClean="0"/>
                <a:t>A</a:t>
              </a:r>
              <a:endParaRPr lang="en-GB" sz="24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572000" y="188640"/>
              <a:ext cx="43204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b="1" dirty="0"/>
                <a:t>B</a:t>
              </a:r>
            </a:p>
          </p:txBody>
        </p:sp>
      </p:grpSp>
      <p:sp>
        <p:nvSpPr>
          <p:cNvPr id="2" name="Rectangle 1"/>
          <p:cNvSpPr/>
          <p:nvPr/>
        </p:nvSpPr>
        <p:spPr>
          <a:xfrm>
            <a:off x="332656" y="5568106"/>
            <a:ext cx="6192688" cy="33239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GB" sz="1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</a:t>
            </a:r>
            <a:r>
              <a:rPr lang="en-GB" sz="10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3.</a:t>
            </a:r>
            <a:r>
              <a:rPr lang="en-GB" sz="10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Phylogenetic analysis of selected plant CAT proteins.</a:t>
            </a: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nalysis of 123 amino-acid sequences in the Cationic Amino Acid Transporter (CAT) subfamily (TC 2.A.3.3) of proteins from 9 species of angiosperms downloaded from the ARAMEMNON plant membrane protein database, release 8.0 (</a:t>
            </a:r>
            <a:r>
              <a:rPr lang="en-GB" sz="1000" u="sng" dirty="0">
                <a:solidFill>
                  <a:srgbClr val="0000FF"/>
                </a:solidFill>
                <a:latin typeface="Times New Roman" panose="02020603050405020304" pitchFamily="18" charset="0"/>
                <a:ea typeface="Times New Roman" panose="02020603050405020304" pitchFamily="18" charset="0"/>
                <a:hlinkClick r:id="rId4"/>
              </a:rPr>
              <a:t>http://aramemnon.botanik.uni-koeln.de/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. Analyses were conducted in MEGA6 (Tamura et al., 2013). Sequence alignment was performed using </a:t>
            </a:r>
            <a:r>
              <a:rPr lang="en-GB" sz="10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lustalW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; all positions with less than 95 % coverage were eliminated, giving a total of 280 positions in the final dataset. Phylogenetic reconstruction was carried out by the </a:t>
            </a:r>
            <a:r>
              <a:rPr lang="en-GB" sz="10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neighbor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joining method with 1000 bootstrap replications using a Poisson substitution model, with non-uniformity of evolutionary rates among sites </a:t>
            </a:r>
            <a:r>
              <a:rPr lang="en-GB" sz="10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odeled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using a discrete Gamma distribution. </a:t>
            </a:r>
            <a:r>
              <a:rPr lang="en-GB" sz="10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GB" sz="1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)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0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Unrooted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radial tree showing bootstrap values ≥ 95 % at the relevant nodes. The CAT9 clade is indicated (100 % bootstrap support</a:t>
            </a:r>
            <a:r>
              <a:rPr lang="en-GB" sz="10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). </a:t>
            </a:r>
            <a:r>
              <a:rPr lang="en-GB" sz="10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GB" sz="1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)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0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Unrooted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rectangular tree showing bootstrap values ≥ 50 % at the relevant nodes. The 9 CAT proteins in the </a:t>
            </a:r>
            <a:r>
              <a:rPr lang="en-GB" sz="10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rabidopsis thaliana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genome are indicated.</a:t>
            </a: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Sequence identifiers begin with the following acronyms for the 9 species of plants: </a:t>
            </a:r>
            <a:r>
              <a:rPr lang="en-GB" sz="10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txg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GB" sz="10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rabidopsis thaliana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; Brad,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Brachypodium</a:t>
            </a:r>
            <a:r>
              <a:rPr lang="en-GB" sz="10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distachyon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; GRMZM and AC207755.3,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Zea</a:t>
            </a:r>
            <a:r>
              <a:rPr lang="en-GB" sz="10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mays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; GSMUSA, </a:t>
            </a:r>
            <a:r>
              <a:rPr lang="en-GB" sz="10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Musa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cuminata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; GSVIV,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itis</a:t>
            </a:r>
            <a:r>
              <a:rPr lang="en-GB" sz="10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inifera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; LOC_Os,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Oryza</a:t>
            </a:r>
            <a:r>
              <a:rPr lang="en-GB" sz="10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ativa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; MELO,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ucumis</a:t>
            </a:r>
            <a:r>
              <a:rPr lang="en-GB" sz="10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elo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; </a:t>
            </a:r>
            <a:r>
              <a:rPr lang="en-GB" sz="10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otri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opulus</a:t>
            </a:r>
            <a:r>
              <a:rPr lang="en-GB" sz="10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richocarpa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; </a:t>
            </a:r>
            <a:r>
              <a:rPr lang="en-GB" sz="10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olyc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olanum</a:t>
            </a:r>
            <a:r>
              <a:rPr lang="en-GB" sz="10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0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lycopersicon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en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2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</dc:creator>
  <cp:lastModifiedBy>Ruddock, Jim - Oxford</cp:lastModifiedBy>
  <cp:revision>83</cp:revision>
  <dcterms:created xsi:type="dcterms:W3CDTF">2013-01-22T12:28:31Z</dcterms:created>
  <dcterms:modified xsi:type="dcterms:W3CDTF">2015-01-13T13:29:14Z</dcterms:modified>
</cp:coreProperties>
</file>